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7023100" cy="93091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2" d="100"/>
          <a:sy n="62" d="100"/>
        </p:scale>
        <p:origin x="1330" y="5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ー サブタイトルの書式設定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786508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586370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560196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684875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335178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829625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 dirty="0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048152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 dirty="0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07317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 dirty="0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149511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39150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887368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3734A1-549B-46EE-AAE4-7289B03A47E7}" type="datetimeFigureOut">
              <a:rPr lang="en-US" smtClean="0"/>
              <a:t>4/22/2016</a:t>
            </a:fld>
            <a:endParaRPr 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902E20-B9F7-42EA-BB8A-2A52F250012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467106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39116835"/>
              </p:ext>
            </p:extLst>
          </p:nvPr>
        </p:nvGraphicFramePr>
        <p:xfrm>
          <a:off x="609599" y="1616174"/>
          <a:ext cx="7924801" cy="3829050"/>
        </p:xfrm>
        <a:graphic>
          <a:graphicData uri="http://schemas.openxmlformats.org/drawingml/2006/table">
            <a:tbl>
              <a:tblPr/>
              <a:tblGrid>
                <a:gridCol w="1171106"/>
                <a:gridCol w="1320271"/>
                <a:gridCol w="2716712"/>
                <a:gridCol w="2716712"/>
              </a:tblGrid>
              <a:tr h="25527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ene name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pecies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orward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everse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527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</a:t>
                      </a:r>
                      <a:r>
                        <a:rPr lang="en-US" sz="11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tl1 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us Musclu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’- cct gtg tgt ggc agt aat gg -3’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’- cca gcc atc tgg aat gat ct -3’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5527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</a:t>
                      </a:r>
                      <a:r>
                        <a:rPr lang="en-US" sz="11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tl1 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attus Norvegicus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’- ctg aaa att gct gga gca gaa -3’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’- gtt tcc agt cag cgt tat ca -3’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527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</a:t>
                      </a:r>
                      <a:r>
                        <a:rPr lang="en-US" sz="11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0a4 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us Musclu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’- ttg tgt cca cct tcc aca aa -3’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’- gct gtc caa gtt gct cat ca -3’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527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</a:t>
                      </a:r>
                      <a:r>
                        <a:rPr lang="en-US" sz="11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0a4 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attus Norvegicus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’- caa cga ggg tga caa gtt ca -3’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’- tgc agg aca gga aga cac ag -3’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527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</a:t>
                      </a:r>
                      <a:r>
                        <a:rPr lang="en-US" sz="11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fb1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us Musclu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’- gtg cgg cag ctg tac att gac ttt -3’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’- tgt act gtg tgt cca ggc tcc aaa -3’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527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ol1a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us Musclu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’- ggg tct aga cat gtt cag ctt tgt g -3’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’- acc ctt agg cca ttg tgt atg c -3’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527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ol1a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us Musclu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’- cagaacatcacctaccactgcaa -3’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’- ttcaacatcgttggaaccctg -3’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527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cta2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us Musclu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’- att gtg ctg gac tct gga gat ggt -3’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’- tga tgt cac gga caa tct cac gct -3’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527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cta2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attus Norvegicus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’-ttc aat gtc cct gcc atg ta -3’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’- gaa gga ata gcc acg ctc ag -3’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527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APDH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us Musclu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’- tca cca cca tgg aga agg c -3’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’- gct aag cag ttg gtg gtg ca -3’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527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APDH 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attus Norvegicus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’- tcaagaaggtggtgaagcag -3’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’- aggtggaagaatgggagttg -3’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527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6b4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us Musclu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’- gct cca agc aga tgc agc a -3’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’- ccg gat gtg agg cag cag -3’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527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6b4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attus Norvegicus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’- tcc tga gcg atg tgc agc tga taa -3’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’- gcc att gtc aaa cac ctg ctg gat -3’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52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n 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us Musclu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rimetime®qPCR primers Mm.PT. 58.8135568 (IDT, 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oralville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, IA)  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4" name="テキスト ボックス 3"/>
          <p:cNvSpPr txBox="1"/>
          <p:nvPr/>
        </p:nvSpPr>
        <p:spPr>
          <a:xfrm>
            <a:off x="609599" y="980728"/>
            <a:ext cx="166744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ble EV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qPCR primers  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749873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26</TotalTime>
  <Words>362</Words>
  <Application>Microsoft Office PowerPoint</Application>
  <PresentationFormat>On-screen Show (4:3)</PresentationFormat>
  <Paragraphs>6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Office ​​テーマ</vt:lpstr>
      <vt:lpstr>PowerPoint Presentation</vt:lpstr>
    </vt:vector>
  </TitlesOfParts>
  <Company>bu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onomi</dc:creator>
  <cp:lastModifiedBy>Whittaker, Linda D</cp:lastModifiedBy>
  <cp:revision>57</cp:revision>
  <cp:lastPrinted>2015-12-11T18:55:13Z</cp:lastPrinted>
  <dcterms:created xsi:type="dcterms:W3CDTF">2015-07-06T18:02:00Z</dcterms:created>
  <dcterms:modified xsi:type="dcterms:W3CDTF">2016-04-22T13:34:57Z</dcterms:modified>
</cp:coreProperties>
</file>